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08" r:id="rId2"/>
    <p:sldId id="423" r:id="rId3"/>
    <p:sldId id="507" r:id="rId4"/>
    <p:sldId id="505" r:id="rId5"/>
    <p:sldId id="51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09F6B-FC8D-BD48-9F44-86CC1A3423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B10F76-BDE6-64FA-9954-70EAF0C299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BB5A85-F600-6A33-C350-EEA527275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6873B-A21D-25C6-4444-5A845E89C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E42A75-708E-E65B-111A-D9B197418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051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54CDF8-BC5C-E14B-5E93-FFB97D9D0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9C80D7-EB5F-B6FE-41B6-7058DBA73A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1FDE0D-96B3-D868-89BF-1375855D99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1C559B-98B5-3ECF-6236-3C3AD50FF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8F987C-2961-44B6-9B34-C56EB164F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908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55B0BD-1898-0816-5C87-1A8C3AE6B7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1A1D2D-0095-9E92-BE91-7DE3D8C3EC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AFDBB6-CBD4-AF7C-FF63-E65556203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F8EEA8-CC47-1D6F-9577-8A9647243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344E15-DF14-CDBD-9538-51939429F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594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4F776-76F2-029E-6E9A-359212067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D2B324-C8D7-012E-F67B-8BB32664A6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AC3901-83CF-DE35-5FFE-C91BAF756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5DEE9A-0490-7C40-DB0A-9B375AC75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84CD4A-A5C8-2226-6715-35B9912B5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60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204B3-F2D9-A5D0-9B6C-8525DBB6B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6FAD3A-8A60-765F-F172-7A06911EB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EB851C-BF7A-8A12-B8CC-5E58E191A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F92FD-F0C9-0D13-33DA-2D3CE8C54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46856-8D5C-BDA6-71FB-9C024AE78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476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BE99-D7B8-A167-A6F8-D4709599A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4C4AAD-0FBC-8689-63BD-9ED7D7F08F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58408A-E7D7-1C5A-8631-7C57B51CFA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AFFD4-9A15-4F72-8A68-CF05CF16E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6C20FE-4886-30FF-1FA0-D6831124C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6D427A-EF72-0943-ECF5-9367F9017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480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389676-B1A1-A125-6AC1-A3CC8B3F0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6DB810-A5C9-C442-F326-89DF547F3D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5E6830-94C8-7449-A83B-CF7BBBE330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6CA8A8-0CEE-C120-4A12-7F2AFEB6F2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6D9A9B-2925-29D2-44A3-60BE991474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FD13E7-2045-FEDC-AA96-94964BD57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7EA3C0-9719-29D4-0455-1AF5924C8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4F21B06-8E06-5840-4F75-0D188ECF2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420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E2644-D993-DE30-1925-2CEA30E9DD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22C7EA-3F1F-49CE-40EA-940256E79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651C1A-D346-CC80-1CEB-209563A11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9A4EE7-53A1-EC4B-32EB-493B94D73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492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57AA1F-068C-B90F-4F8C-09202E7BD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2F2C140-1C02-C7A7-249B-8469B597B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97929C-1F09-0770-DEAC-E199EFA54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384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5F885-9A4E-00F2-F8D4-8CD156346B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FDEB5-C39C-31B0-AD5D-E27DA98D25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C3760D-EBD1-8648-9DFA-11C7632396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0EE495-71AA-518A-E925-D36C540B0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3ABD4B-9211-B762-0EE8-3620E1D31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3060BE-BD71-0E43-75FD-E2C8411E2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83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256D8-058D-D89C-16EB-0EF429AB62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D20ECA-0A15-18B1-FC8D-BE5B5BBE97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A41D6F-FED6-F0AB-804E-B247B7472C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4DA9EF-0EF5-4053-586A-0BC5F9B98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90FBA3-36F9-03C8-AA4D-8AE237231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A79E5F-BE46-F93E-9894-F3389293C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692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E1C7F8-A149-261C-967E-1154B16213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B41E6D-EAD4-5CD7-B043-0A5D2AE0E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3CD93-30D9-41B8-DB5C-B4A2D71EE2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CC7300-E8C9-4F4C-8931-64377037A643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8795C-ADF4-A74C-3C6A-37DBF82F21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8771F-87D1-CAD8-47A8-F0FAE5B259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3762B4-0667-44D8-B215-692AD7F959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234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ED72D63-4391-A581-DAA0-7A9428AD2DD4}"/>
              </a:ext>
            </a:extLst>
          </p:cNvPr>
          <p:cNvSpPr txBox="1"/>
          <p:nvPr/>
        </p:nvSpPr>
        <p:spPr>
          <a:xfrm>
            <a:off x="598206" y="632753"/>
            <a:ext cx="8379281" cy="60121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7-RRA          MKKAVFTTLIGLYATHVMGIRHTNSLPGRSQDAMLVDALASGLSESYARINAIEDETDIA 6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9t3BO-RRA      MKKAVFTTLIGLYATHVMGIRHTNSLPGRSQDAMLVDALASGLSESYARINAIEDETDIA 6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GENTINA-RRA    MKKAVFTTLIGLYATHVMGIRHTNSLPGRSQDAMLVDALASGLSESYARINAIEDETDIA 6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STRALIA-RRA    MKKAVFTTLIGLYATHVMGIRHTNSLPGRSQDAMLVDALASGLSESYARINAIEDETDIA 6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************************************************************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7-RRA          FRMVESIRHNPNIQDAVCARFIKKQLCHEIVTVYVRRCSQGQCAILDTEQHPLNDPN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I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2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9t3BO-RRA      FRMVESIRHNPNIQDAVCARFIKKQLCHEIVTVYVRRCSQGQCAILDTEQHPLNDPN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I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20 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GENTINA-RRA    FRMVESIRHNPNIQDAVCARFIKKQLCHEIVTVYVRRCSQGQCAILDTEQHPLNDPN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I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20	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STRALIA-RRA    FRMVESIRHNPNIQDAVCARFIKKQLCHEIVTVYVRRCSQGQCAILDTEQHPLNDPN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TI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2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*********************************************************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7-RRA          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PNTYQLEAAF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IFKNLLKQYSKQRHMEGKRFRSKSKSNLYRLFMSLLMRKNMFFRKID 18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9t3BO-RRA      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PNTYQLEAAF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IFKNLLKQYSKQRHMEGKRFRSKSKSNLYRLFMSLLMRKNMFFRKID 18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GENTINA-RRA    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PNTYQLEAAF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IFKNLLKQYSKQRHMEGKRFRSKSKSNLYRLFMSLLMRKNMFFRKID 18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STRALIA-RRA    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LPNTYQLEAAF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IFKNLLKQYSKQRHMEGKRFRSKSKSNLYRLFMSLLMRKNMFFRKID 18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</a:t>
            </a:r>
            <a:r>
              <a:rPr lang="en-US" sz="12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*********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*********************************************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7-RRA          RRDLFLSRYLFMTTIYYKTYTTIEKMKTSLQNNMKIARYLCSKRIRKALGNILKVNIRGA 24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9t3BO-RRA      RRDLFLSRYLFMTTIYYKTYTTIEKMKTSLQNNMKIARYLCSKRIRKALGNILKVNIRGA 24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GENTINA-RRA    RRDLFLSRYLFMTTIYYKTYTTIEKMKTSLQNNMKIARYLCSKRIRKALGNILKVNIRGA 24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STRALIA-RRA    RRDLFLSRYLFMTTIYYKTYTTIEKMKTSLQNNMKIARYLCSKRIRKALGNILKVNIRGA 240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************************************************************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7-RRA          VKDTPANYITAKTRDYEIYLRRQQSE	                                  266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9t3BO-RRA      VKDTPANYITAKTRDYEIYLRRQQSE	                                  266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GENTINA-RRA    VKDTPANYITAKTRDYEIYLRRQQSE	                                  </a:t>
            </a:r>
            <a:r>
              <a:rPr lang="en-US" sz="1200" kern="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66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STRALIA-RRA    VKDTPANYITAKTRDYEIYLRRQQSE	                                  266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2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**************************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9CBAE40-C0DE-1831-C7AC-BD059923510A}"/>
              </a:ext>
            </a:extLst>
          </p:cNvPr>
          <p:cNvSpPr txBox="1"/>
          <p:nvPr/>
        </p:nvSpPr>
        <p:spPr>
          <a:xfrm>
            <a:off x="9253672" y="6460246"/>
            <a:ext cx="31172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244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50B92C3-1692-E3A8-D9A4-B051A4C06D23}"/>
              </a:ext>
            </a:extLst>
          </p:cNvPr>
          <p:cNvSpPr txBox="1"/>
          <p:nvPr/>
        </p:nvSpPr>
        <p:spPr>
          <a:xfrm>
            <a:off x="8871816" y="6488668"/>
            <a:ext cx="29570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 2</a:t>
            </a:r>
          </a:p>
        </p:txBody>
      </p:sp>
      <p:grpSp>
        <p:nvGrpSpPr>
          <p:cNvPr id="2" name="Group 4">
            <a:extLst>
              <a:ext uri="{FF2B5EF4-FFF2-40B4-BE49-F238E27FC236}">
                <a16:creationId xmlns:a16="http://schemas.microsoft.com/office/drawing/2014/main" id="{677BED8F-B8F5-E7F9-C518-2B4CBD29D99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240704" y="281648"/>
            <a:ext cx="8378824" cy="5810762"/>
            <a:chOff x="895" y="-79"/>
            <a:chExt cx="5278" cy="3531"/>
          </a:xfrm>
          <a:noFill/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7CE38B0E-1981-5478-330D-B6760B19E4E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95" y="366"/>
              <a:ext cx="5277" cy="3086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16512D1-DB80-B16D-4C73-5E425C1F5D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6" y="63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E50F487-8B38-41D5-C911-956380699C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-79"/>
              <a:ext cx="5274" cy="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9">
              <a:extLst>
                <a:ext uri="{FF2B5EF4-FFF2-40B4-BE49-F238E27FC236}">
                  <a16:creationId xmlns:a16="http://schemas.microsoft.com/office/drawing/2014/main" id="{C38A7CA0-B1C4-8775-BCD4-7E6E1F1473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-79"/>
              <a:ext cx="3" cy="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10">
              <a:extLst>
                <a:ext uri="{FF2B5EF4-FFF2-40B4-BE49-F238E27FC236}">
                  <a16:creationId xmlns:a16="http://schemas.microsoft.com/office/drawing/2014/main" id="{973A143D-8185-F6DC-C758-C0433EA021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-71"/>
              <a:ext cx="3" cy="29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11">
              <a:extLst>
                <a:ext uri="{FF2B5EF4-FFF2-40B4-BE49-F238E27FC236}">
                  <a16:creationId xmlns:a16="http://schemas.microsoft.com/office/drawing/2014/main" id="{C5B102C0-F90A-8AEA-952A-0A9ADC6143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-71"/>
              <a:ext cx="3" cy="29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13">
              <a:extLst>
                <a:ext uri="{FF2B5EF4-FFF2-40B4-BE49-F238E27FC236}">
                  <a16:creationId xmlns:a16="http://schemas.microsoft.com/office/drawing/2014/main" id="{720764B2-DF82-9545-39A4-9B79D98DCD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26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4">
              <a:extLst>
                <a:ext uri="{FF2B5EF4-FFF2-40B4-BE49-F238E27FC236}">
                  <a16:creationId xmlns:a16="http://schemas.microsoft.com/office/drawing/2014/main" id="{EF5E6651-FA4A-5015-652B-C47D9AD4A1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20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15">
              <a:extLst>
                <a:ext uri="{FF2B5EF4-FFF2-40B4-BE49-F238E27FC236}">
                  <a16:creationId xmlns:a16="http://schemas.microsoft.com/office/drawing/2014/main" id="{E31BCFD2-A6F5-6128-2652-9740519364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20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17">
              <a:extLst>
                <a:ext uri="{FF2B5EF4-FFF2-40B4-BE49-F238E27FC236}">
                  <a16:creationId xmlns:a16="http://schemas.microsoft.com/office/drawing/2014/main" id="{51B9B771-3321-9032-CB4B-F08E86E8D5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389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id="{D7C0DA30-87D4-9AE8-1E2A-CDE9D7518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383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19">
              <a:extLst>
                <a:ext uri="{FF2B5EF4-FFF2-40B4-BE49-F238E27FC236}">
                  <a16:creationId xmlns:a16="http://schemas.microsoft.com/office/drawing/2014/main" id="{2E255667-EB48-86A4-0EAD-E10962A10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383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Rectangle 20">
              <a:extLst>
                <a:ext uri="{FF2B5EF4-FFF2-40B4-BE49-F238E27FC236}">
                  <a16:creationId xmlns:a16="http://schemas.microsoft.com/office/drawing/2014/main" id="{E8CAAC1F-F5AE-B894-C927-E51B25E8E9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545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1">
              <a:extLst>
                <a:ext uri="{FF2B5EF4-FFF2-40B4-BE49-F238E27FC236}">
                  <a16:creationId xmlns:a16="http://schemas.microsoft.com/office/drawing/2014/main" id="{31C91B0F-4A15-7A9A-F154-A334002DF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550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ap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">
              <a:extLst>
                <a:ext uri="{FF2B5EF4-FFF2-40B4-BE49-F238E27FC236}">
                  <a16:creationId xmlns:a16="http://schemas.microsoft.com/office/drawing/2014/main" id="{7D0E2EBC-710D-AE95-E270-D3A0A5C55C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7" y="550"/>
              <a:ext cx="4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3">
              <a:extLst>
                <a:ext uri="{FF2B5EF4-FFF2-40B4-BE49-F238E27FC236}">
                  <a16:creationId xmlns:a16="http://schemas.microsoft.com/office/drawing/2014/main" id="{01DBCF32-03FC-C795-F652-66EB3DF5CA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" y="550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4">
              <a:extLst>
                <a:ext uri="{FF2B5EF4-FFF2-40B4-BE49-F238E27FC236}">
                  <a16:creationId xmlns:a16="http://schemas.microsoft.com/office/drawing/2014/main" id="{A8F218A9-31AA-BDB1-BBB9-FB3ABFDFC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550"/>
              <a:ext cx="169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MRIISGVVGCLFLVFSHHVSAFR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5">
              <a:extLst>
                <a:ext uri="{FF2B5EF4-FFF2-40B4-BE49-F238E27FC236}">
                  <a16:creationId xmlns:a16="http://schemas.microsoft.com/office/drawing/2014/main" id="{D4A7DF06-4787-AAC1-3FF2-8F3A3D603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3" y="550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6">
              <a:extLst>
                <a:ext uri="{FF2B5EF4-FFF2-40B4-BE49-F238E27FC236}">
                  <a16:creationId xmlns:a16="http://schemas.microsoft.com/office/drawing/2014/main" id="{16692A5D-D0BA-A58D-D960-C18C73695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7" y="550"/>
              <a:ext cx="115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NQRVGSLAPAEVVGD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7">
              <a:extLst>
                <a:ext uri="{FF2B5EF4-FFF2-40B4-BE49-F238E27FC236}">
                  <a16:creationId xmlns:a16="http://schemas.microsoft.com/office/drawing/2014/main" id="{BD90D8F3-07EC-15FC-82E3-0F9C872265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3" y="550"/>
              <a:ext cx="1360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TSTLETADTLMTLRDHMH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8">
              <a:extLst>
                <a:ext uri="{FF2B5EF4-FFF2-40B4-BE49-F238E27FC236}">
                  <a16:creationId xmlns:a16="http://schemas.microsoft.com/office/drawing/2014/main" id="{5ABC1448-AD07-D5D4-AA71-E6FA1D181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550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9">
              <a:extLst>
                <a:ext uri="{FF2B5EF4-FFF2-40B4-BE49-F238E27FC236}">
                  <a16:creationId xmlns:a16="http://schemas.microsoft.com/office/drawing/2014/main" id="{F446E945-437D-05D2-51E5-58D8823D0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545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Rectangle 30">
              <a:extLst>
                <a:ext uri="{FF2B5EF4-FFF2-40B4-BE49-F238E27FC236}">
                  <a16:creationId xmlns:a16="http://schemas.microsoft.com/office/drawing/2014/main" id="{8E1DF7C4-F6AD-EA66-01D2-59BA880B2A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545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31">
              <a:extLst>
                <a:ext uri="{FF2B5EF4-FFF2-40B4-BE49-F238E27FC236}">
                  <a16:creationId xmlns:a16="http://schemas.microsoft.com/office/drawing/2014/main" id="{23FE01E0-CD31-636A-87A1-58F8ACE26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708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Rectangle 32">
              <a:extLst>
                <a:ext uri="{FF2B5EF4-FFF2-40B4-BE49-F238E27FC236}">
                  <a16:creationId xmlns:a16="http://schemas.microsoft.com/office/drawing/2014/main" id="{4598C783-5FB3-7F34-44E6-F7CA7F61FB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713"/>
              <a:ext cx="951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RA        MK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3">
              <a:extLst>
                <a:ext uri="{FF2B5EF4-FFF2-40B4-BE49-F238E27FC236}">
                  <a16:creationId xmlns:a16="http://schemas.microsoft.com/office/drawing/2014/main" id="{FB28B342-6F9E-4438-B544-FD8FA94CE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0" y="713"/>
              <a:ext cx="203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-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4">
              <a:extLst>
                <a:ext uri="{FF2B5EF4-FFF2-40B4-BE49-F238E27FC236}">
                  <a16:creationId xmlns:a16="http://schemas.microsoft.com/office/drawing/2014/main" id="{36F96E1A-4AD6-9A4A-8726-029FED201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9" y="713"/>
              <a:ext cx="38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KAVFTTLIGLYATHVMGIRHTNSLPGRSQDAMLVDALASGLSESYARINAIEDETD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5">
              <a:extLst>
                <a:ext uri="{FF2B5EF4-FFF2-40B4-BE49-F238E27FC236}">
                  <a16:creationId xmlns:a16="http://schemas.microsoft.com/office/drawing/2014/main" id="{C17D27AF-387E-674F-2871-79CE31D4C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713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6">
              <a:extLst>
                <a:ext uri="{FF2B5EF4-FFF2-40B4-BE49-F238E27FC236}">
                  <a16:creationId xmlns:a16="http://schemas.microsoft.com/office/drawing/2014/main" id="{9E52ECCB-703B-6C3D-8BE0-EFC1CE2B2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70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Rectangle 37">
              <a:extLst>
                <a:ext uri="{FF2B5EF4-FFF2-40B4-BE49-F238E27FC236}">
                  <a16:creationId xmlns:a16="http://schemas.microsoft.com/office/drawing/2014/main" id="{03F8386B-0BCE-75FD-E487-215DE54FDD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70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Rectangle 38">
              <a:extLst>
                <a:ext uri="{FF2B5EF4-FFF2-40B4-BE49-F238E27FC236}">
                  <a16:creationId xmlns:a16="http://schemas.microsoft.com/office/drawing/2014/main" id="{F7477614-543E-A7B8-953B-7E0665101E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871"/>
              <a:ext cx="5077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Rectangle 39">
              <a:extLst>
                <a:ext uri="{FF2B5EF4-FFF2-40B4-BE49-F238E27FC236}">
                  <a16:creationId xmlns:a16="http://schemas.microsoft.com/office/drawing/2014/main" id="{B300DF6A-8047-C62E-0FFA-1C2851B6D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876"/>
              <a:ext cx="81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40">
              <a:extLst>
                <a:ext uri="{FF2B5EF4-FFF2-40B4-BE49-F238E27FC236}">
                  <a16:creationId xmlns:a16="http://schemas.microsoft.com/office/drawing/2014/main" id="{0C2027AA-23CD-ABF6-2354-032BE37F3A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876"/>
              <a:ext cx="414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*:  ..*.  *: ::: ** .:** *.  *    * :*. *:* *. : : :.  :.  :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1">
              <a:extLst>
                <a:ext uri="{FF2B5EF4-FFF2-40B4-BE49-F238E27FC236}">
                  <a16:creationId xmlns:a16="http://schemas.microsoft.com/office/drawing/2014/main" id="{1F292F8B-2CA4-EB20-772A-E8A1335D3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876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2">
              <a:extLst>
                <a:ext uri="{FF2B5EF4-FFF2-40B4-BE49-F238E27FC236}">
                  <a16:creationId xmlns:a16="http://schemas.microsoft.com/office/drawing/2014/main" id="{746C6AFB-F07A-D83A-47C2-ED48056CA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871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Rectangle 43">
              <a:extLst>
                <a:ext uri="{FF2B5EF4-FFF2-40B4-BE49-F238E27FC236}">
                  <a16:creationId xmlns:a16="http://schemas.microsoft.com/office/drawing/2014/main" id="{E1D3A1E7-E133-6449-0521-CE1A75405F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871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Rectangle 44">
              <a:extLst>
                <a:ext uri="{FF2B5EF4-FFF2-40B4-BE49-F238E27FC236}">
                  <a16:creationId xmlns:a16="http://schemas.microsoft.com/office/drawing/2014/main" id="{14DBA23C-11BC-4336-5298-FCB12E89D6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033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45">
              <a:extLst>
                <a:ext uri="{FF2B5EF4-FFF2-40B4-BE49-F238E27FC236}">
                  <a16:creationId xmlns:a16="http://schemas.microsoft.com/office/drawing/2014/main" id="{258C4EEA-A951-BEBF-8AAD-E605D499A6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038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6">
              <a:extLst>
                <a:ext uri="{FF2B5EF4-FFF2-40B4-BE49-F238E27FC236}">
                  <a16:creationId xmlns:a16="http://schemas.microsoft.com/office/drawing/2014/main" id="{08359AF9-1461-B6D3-6E92-DBE8A2913C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03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47">
              <a:extLst>
                <a:ext uri="{FF2B5EF4-FFF2-40B4-BE49-F238E27FC236}">
                  <a16:creationId xmlns:a16="http://schemas.microsoft.com/office/drawing/2014/main" id="{795AB809-C5E4-F360-9AC5-9A832EE6C6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03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Rectangle 48">
              <a:extLst>
                <a:ext uri="{FF2B5EF4-FFF2-40B4-BE49-F238E27FC236}">
                  <a16:creationId xmlns:a16="http://schemas.microsoft.com/office/drawing/2014/main" id="{70805A62-EAA0-B626-6157-0256524843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196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Rectangle 49">
              <a:extLst>
                <a:ext uri="{FF2B5EF4-FFF2-40B4-BE49-F238E27FC236}">
                  <a16:creationId xmlns:a16="http://schemas.microsoft.com/office/drawing/2014/main" id="{CDC39529-7F8D-89FE-A100-D521B0AC0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201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ap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0">
              <a:extLst>
                <a:ext uri="{FF2B5EF4-FFF2-40B4-BE49-F238E27FC236}">
                  <a16:creationId xmlns:a16="http://schemas.microsoft.com/office/drawing/2014/main" id="{A1B2FBFC-E122-C0E7-8E14-E12D5E0DB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7" y="1201"/>
              <a:ext cx="4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1">
              <a:extLst>
                <a:ext uri="{FF2B5EF4-FFF2-40B4-BE49-F238E27FC236}">
                  <a16:creationId xmlns:a16="http://schemas.microsoft.com/office/drawing/2014/main" id="{456C6F03-F4F8-6E5D-F928-65E2B9F45B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" y="1201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2">
              <a:extLst>
                <a:ext uri="{FF2B5EF4-FFF2-40B4-BE49-F238E27FC236}">
                  <a16:creationId xmlns:a16="http://schemas.microsoft.com/office/drawing/2014/main" id="{23D35789-73A7-FB7C-FA78-88F7DA101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1201"/>
              <a:ext cx="414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ITKDMKHVLSNGREQIVNDVCSNAPEDSNCREVVNNYADRCEMYGCFTIDNVKYPLYQEY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3">
              <a:extLst>
                <a:ext uri="{FF2B5EF4-FFF2-40B4-BE49-F238E27FC236}">
                  <a16:creationId xmlns:a16="http://schemas.microsoft.com/office/drawing/2014/main" id="{54904242-E051-3B36-B73E-17C21ABCE1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1201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4">
              <a:extLst>
                <a:ext uri="{FF2B5EF4-FFF2-40B4-BE49-F238E27FC236}">
                  <a16:creationId xmlns:a16="http://schemas.microsoft.com/office/drawing/2014/main" id="{6169B57D-218C-D6A3-8953-7D546078B3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196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55">
              <a:extLst>
                <a:ext uri="{FF2B5EF4-FFF2-40B4-BE49-F238E27FC236}">
                  <a16:creationId xmlns:a16="http://schemas.microsoft.com/office/drawing/2014/main" id="{1F1455CE-E196-0022-6646-44162D091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196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Rectangle 56">
              <a:extLst>
                <a:ext uri="{FF2B5EF4-FFF2-40B4-BE49-F238E27FC236}">
                  <a16:creationId xmlns:a16="http://schemas.microsoft.com/office/drawing/2014/main" id="{E7BD3D37-F1C1-443B-02FD-82FA7D5A84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359"/>
              <a:ext cx="5077" cy="16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Rectangle 57">
              <a:extLst>
                <a:ext uri="{FF2B5EF4-FFF2-40B4-BE49-F238E27FC236}">
                  <a16:creationId xmlns:a16="http://schemas.microsoft.com/office/drawing/2014/main" id="{6DCD1E4B-E6CC-F81D-C993-BAA81FA73B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364"/>
              <a:ext cx="1360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RA        IAFRMVE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8">
              <a:extLst>
                <a:ext uri="{FF2B5EF4-FFF2-40B4-BE49-F238E27FC236}">
                  <a16:creationId xmlns:a16="http://schemas.microsoft.com/office/drawing/2014/main" id="{394E7493-0CAC-F79B-6D95-9EE106C47D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8" y="1364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IRH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9">
              <a:extLst>
                <a:ext uri="{FF2B5EF4-FFF2-40B4-BE49-F238E27FC236}">
                  <a16:creationId xmlns:a16="http://schemas.microsoft.com/office/drawing/2014/main" id="{B945A544-B752-AF8D-61EC-5AC60331D4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" y="1364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0">
              <a:extLst>
                <a:ext uri="{FF2B5EF4-FFF2-40B4-BE49-F238E27FC236}">
                  <a16:creationId xmlns:a16="http://schemas.microsoft.com/office/drawing/2014/main" id="{27580D65-4324-C310-F0E9-30FD4A6C5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1" y="1364"/>
              <a:ext cx="3263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PNIQDAVCARFIKKQLCHEIVTVYVRRCSQGQCAILDTEQHPLNDP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1">
              <a:extLst>
                <a:ext uri="{FF2B5EF4-FFF2-40B4-BE49-F238E27FC236}">
                  <a16:creationId xmlns:a16="http://schemas.microsoft.com/office/drawing/2014/main" id="{26657E16-C318-B58D-6BD4-2DE8F21519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1364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2">
              <a:extLst>
                <a:ext uri="{FF2B5EF4-FFF2-40B4-BE49-F238E27FC236}">
                  <a16:creationId xmlns:a16="http://schemas.microsoft.com/office/drawing/2014/main" id="{6625D975-45CF-646F-AA72-2A40125CFB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359"/>
              <a:ext cx="3" cy="16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63">
              <a:extLst>
                <a:ext uri="{FF2B5EF4-FFF2-40B4-BE49-F238E27FC236}">
                  <a16:creationId xmlns:a16="http://schemas.microsoft.com/office/drawing/2014/main" id="{C6133DF9-F736-F98B-52ED-693FEB0B2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359"/>
              <a:ext cx="3" cy="16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Rectangle 64">
              <a:extLst>
                <a:ext uri="{FF2B5EF4-FFF2-40B4-BE49-F238E27FC236}">
                  <a16:creationId xmlns:a16="http://schemas.microsoft.com/office/drawing/2014/main" id="{17031710-AD9C-2A0A-0AB2-4ECAABF80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520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Rectangle 65">
              <a:extLst>
                <a:ext uri="{FF2B5EF4-FFF2-40B4-BE49-F238E27FC236}">
                  <a16:creationId xmlns:a16="http://schemas.microsoft.com/office/drawing/2014/main" id="{4AAA8699-30FE-2632-352F-88F996E375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526"/>
              <a:ext cx="81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6">
              <a:extLst>
                <a:ext uri="{FF2B5EF4-FFF2-40B4-BE49-F238E27FC236}">
                  <a16:creationId xmlns:a16="http://schemas.microsoft.com/office/drawing/2014/main" id="{D14310EE-DDD8-FEBF-9C29-D79F28523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1526"/>
              <a:ext cx="414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*:  * . : :.  :* : **:.  :.. *:*:*. *. **.   *  :*. ::** :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7">
              <a:extLst>
                <a:ext uri="{FF2B5EF4-FFF2-40B4-BE49-F238E27FC236}">
                  <a16:creationId xmlns:a16="http://schemas.microsoft.com/office/drawing/2014/main" id="{82F03D10-CEB3-E4C2-C8B2-996C8A4358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1526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8">
              <a:extLst>
                <a:ext uri="{FF2B5EF4-FFF2-40B4-BE49-F238E27FC236}">
                  <a16:creationId xmlns:a16="http://schemas.microsoft.com/office/drawing/2014/main" id="{8E17C33B-D149-CDD2-2007-F1F0F78AA0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520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69">
              <a:extLst>
                <a:ext uri="{FF2B5EF4-FFF2-40B4-BE49-F238E27FC236}">
                  <a16:creationId xmlns:a16="http://schemas.microsoft.com/office/drawing/2014/main" id="{A12A464E-50D7-04CA-7687-5291446EFB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520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Rectangle 70">
              <a:extLst>
                <a:ext uri="{FF2B5EF4-FFF2-40B4-BE49-F238E27FC236}">
                  <a16:creationId xmlns:a16="http://schemas.microsoft.com/office/drawing/2014/main" id="{2564B970-4F7B-B98F-6BB8-9B0D118DE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683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Rectangle 71">
              <a:extLst>
                <a:ext uri="{FF2B5EF4-FFF2-40B4-BE49-F238E27FC236}">
                  <a16:creationId xmlns:a16="http://schemas.microsoft.com/office/drawing/2014/main" id="{7F3F908C-57AB-70A1-0CDE-7821CEBAA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689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2">
              <a:extLst>
                <a:ext uri="{FF2B5EF4-FFF2-40B4-BE49-F238E27FC236}">
                  <a16:creationId xmlns:a16="http://schemas.microsoft.com/office/drawing/2014/main" id="{C495F7A0-D961-66A7-44F4-837486A73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68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" name="Rectangle 73">
              <a:extLst>
                <a:ext uri="{FF2B5EF4-FFF2-40B4-BE49-F238E27FC236}">
                  <a16:creationId xmlns:a16="http://schemas.microsoft.com/office/drawing/2014/main" id="{3518FBED-73BD-F3B3-6721-51FBE6512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68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Rectangle 74">
              <a:extLst>
                <a:ext uri="{FF2B5EF4-FFF2-40B4-BE49-F238E27FC236}">
                  <a16:creationId xmlns:a16="http://schemas.microsoft.com/office/drawing/2014/main" id="{CF038490-4DB1-43B9-E310-55ECD95E25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1846"/>
              <a:ext cx="5077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Rectangle 75">
              <a:extLst>
                <a:ext uri="{FF2B5EF4-FFF2-40B4-BE49-F238E27FC236}">
                  <a16:creationId xmlns:a16="http://schemas.microsoft.com/office/drawing/2014/main" id="{5C95763D-6976-70CB-7556-92AB401174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1852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ap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6">
              <a:extLst>
                <a:ext uri="{FF2B5EF4-FFF2-40B4-BE49-F238E27FC236}">
                  <a16:creationId xmlns:a16="http://schemas.microsoft.com/office/drawing/2014/main" id="{7857601B-BAAB-6027-9ACC-A363496E12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7" y="1852"/>
              <a:ext cx="4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7">
              <a:extLst>
                <a:ext uri="{FF2B5EF4-FFF2-40B4-BE49-F238E27FC236}">
                  <a16:creationId xmlns:a16="http://schemas.microsoft.com/office/drawing/2014/main" id="{A07211F5-C770-B99F-CAA5-36E510DEB8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" y="1852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8">
              <a:extLst>
                <a:ext uri="{FF2B5EF4-FFF2-40B4-BE49-F238E27FC236}">
                  <a16:creationId xmlns:a16="http://schemas.microsoft.com/office/drawing/2014/main" id="{8F696F70-85A7-3B61-7750-2919214EAF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1852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4472C4"/>
                  </a:solidFill>
                  <a:effectLst/>
                  <a:latin typeface="Courier New" panose="02070309020205020404" pitchFamily="49" charset="0"/>
                </a:rPr>
                <a:t>QPL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9">
              <a:extLst>
                <a:ext uri="{FF2B5EF4-FFF2-40B4-BE49-F238E27FC236}">
                  <a16:creationId xmlns:a16="http://schemas.microsoft.com/office/drawing/2014/main" id="{E3778F12-F02C-BE78-A19A-4A611CBCB0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9" y="1852"/>
              <a:ext cx="272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Courier New" panose="02070309020205020404" pitchFamily="49" charset="0"/>
                </a:rPr>
                <a:t>LP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80">
              <a:extLst>
                <a:ext uri="{FF2B5EF4-FFF2-40B4-BE49-F238E27FC236}">
                  <a16:creationId xmlns:a16="http://schemas.microsoft.com/office/drawing/2014/main" id="{C376ADBE-E159-06EB-551F-426EFBB861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1852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4472C4"/>
                  </a:solidFill>
                  <a:effectLst/>
                  <a:latin typeface="Courier New" panose="02070309020205020404" pitchFamily="49" charset="0"/>
                </a:rPr>
                <a:t>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1">
              <a:extLst>
                <a:ext uri="{FF2B5EF4-FFF2-40B4-BE49-F238E27FC236}">
                  <a16:creationId xmlns:a16="http://schemas.microsoft.com/office/drawing/2014/main" id="{3B11F7E7-0006-7262-FB3C-A001A7E329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8" y="1852"/>
              <a:ext cx="272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Courier New" panose="02070309020205020404" pitchFamily="49" charset="0"/>
                </a:rPr>
                <a:t>YQ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2">
              <a:extLst>
                <a:ext uri="{FF2B5EF4-FFF2-40B4-BE49-F238E27FC236}">
                  <a16:creationId xmlns:a16="http://schemas.microsoft.com/office/drawing/2014/main" id="{BC7F1708-BCA7-BB52-3D20-5AE1C4D11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" y="1852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4472C4"/>
                  </a:solidFill>
                  <a:effectLst/>
                  <a:latin typeface="Courier New" panose="02070309020205020404" pitchFamily="49" charset="0"/>
                </a:rPr>
                <a:t>D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3">
              <a:extLst>
                <a:ext uri="{FF2B5EF4-FFF2-40B4-BE49-F238E27FC236}">
                  <a16:creationId xmlns:a16="http://schemas.microsoft.com/office/drawing/2014/main" id="{EE8B70C1-8E7A-F028-D3B9-84B56AD84F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" y="1852"/>
              <a:ext cx="272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Courier New" panose="02070309020205020404" pitchFamily="49" charset="0"/>
                </a:rPr>
                <a:t>AAF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4">
              <a:extLst>
                <a:ext uri="{FF2B5EF4-FFF2-40B4-BE49-F238E27FC236}">
                  <a16:creationId xmlns:a16="http://schemas.microsoft.com/office/drawing/2014/main" id="{AEA6ED52-D72D-3952-EB1F-53EE5E9FE6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" y="1852"/>
              <a:ext cx="312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LFKESASNPAKNSVKREWLRFRNGANHGDYHYFVTGLLNNNVVH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5">
              <a:extLst>
                <a:ext uri="{FF2B5EF4-FFF2-40B4-BE49-F238E27FC236}">
                  <a16:creationId xmlns:a16="http://schemas.microsoft.com/office/drawing/2014/main" id="{E4B8D1AC-898F-4343-0814-1DC49B6D2E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1852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6">
              <a:extLst>
                <a:ext uri="{FF2B5EF4-FFF2-40B4-BE49-F238E27FC236}">
                  <a16:creationId xmlns:a16="http://schemas.microsoft.com/office/drawing/2014/main" id="{088F9F4A-D75B-2BA7-09D5-3376996D1F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1846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87">
              <a:extLst>
                <a:ext uri="{FF2B5EF4-FFF2-40B4-BE49-F238E27FC236}">
                  <a16:creationId xmlns:a16="http://schemas.microsoft.com/office/drawing/2014/main" id="{4B289B22-9576-336E-EB2F-5EEC9A756A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1846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Rectangle 88">
              <a:extLst>
                <a:ext uri="{FF2B5EF4-FFF2-40B4-BE49-F238E27FC236}">
                  <a16:creationId xmlns:a16="http://schemas.microsoft.com/office/drawing/2014/main" id="{F62BB9F5-845E-5F1C-4914-6BB7F50F5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008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89">
              <a:extLst>
                <a:ext uri="{FF2B5EF4-FFF2-40B4-BE49-F238E27FC236}">
                  <a16:creationId xmlns:a16="http://schemas.microsoft.com/office/drawing/2014/main" id="{0CA84F51-1C38-F575-2846-19006320FA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013"/>
              <a:ext cx="81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RA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0">
              <a:extLst>
                <a:ext uri="{FF2B5EF4-FFF2-40B4-BE49-F238E27FC236}">
                  <a16:creationId xmlns:a16="http://schemas.microsoft.com/office/drawing/2014/main" id="{9088F468-D129-B917-3D90-2EF3C735AC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2013"/>
              <a:ext cx="108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FF0000"/>
                  </a:solidFill>
                  <a:effectLst/>
                  <a:latin typeface="Courier New" panose="02070309020205020404" pitchFamily="49" charset="0"/>
                </a:rPr>
                <a:t>PTIRLPNTYQLEAAF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1">
              <a:extLst>
                <a:ext uri="{FF2B5EF4-FFF2-40B4-BE49-F238E27FC236}">
                  <a16:creationId xmlns:a16="http://schemas.microsoft.com/office/drawing/2014/main" id="{0ED602A6-444F-119E-4150-FFE3D723FF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" y="2013"/>
              <a:ext cx="1020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YIFKNLLKQYSKQ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2">
              <a:extLst>
                <a:ext uri="{FF2B5EF4-FFF2-40B4-BE49-F238E27FC236}">
                  <a16:creationId xmlns:a16="http://schemas.microsoft.com/office/drawing/2014/main" id="{707F7CCE-24AF-0CB7-3259-89DDA51A0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6" y="2013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8923DE70-8C21-1DE5-C29B-923683230F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1" y="2013"/>
              <a:ext cx="1223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HMEGKRFRSKSKSNLYR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4">
              <a:extLst>
                <a:ext uri="{FF2B5EF4-FFF2-40B4-BE49-F238E27FC236}">
                  <a16:creationId xmlns:a16="http://schemas.microsoft.com/office/drawing/2014/main" id="{D73336B6-1129-E9F5-A270-0EFD963660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1" y="2013"/>
              <a:ext cx="951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LFMSLLMRKNMFF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6059B383-0E5D-3ED9-9ED4-D0B18A63B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2013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6">
              <a:extLst>
                <a:ext uri="{FF2B5EF4-FFF2-40B4-BE49-F238E27FC236}">
                  <a16:creationId xmlns:a16="http://schemas.microsoft.com/office/drawing/2014/main" id="{888C52DF-4FBA-5390-DCCA-CBDBF49BC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00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Rectangle 97">
              <a:extLst>
                <a:ext uri="{FF2B5EF4-FFF2-40B4-BE49-F238E27FC236}">
                  <a16:creationId xmlns:a16="http://schemas.microsoft.com/office/drawing/2014/main" id="{CA9683D0-D9C8-5AD2-988B-6B74B91A7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00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Rectangle 98">
              <a:extLst>
                <a:ext uri="{FF2B5EF4-FFF2-40B4-BE49-F238E27FC236}">
                  <a16:creationId xmlns:a16="http://schemas.microsoft.com/office/drawing/2014/main" id="{F94FFBA5-D9B6-B7E8-5B53-1431B21C99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171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99">
              <a:extLst>
                <a:ext uri="{FF2B5EF4-FFF2-40B4-BE49-F238E27FC236}">
                  <a16:creationId xmlns:a16="http://schemas.microsoft.com/office/drawing/2014/main" id="{F8910AE6-E3AC-41EB-93F1-A082E9F989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176"/>
              <a:ext cx="884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0">
              <a:extLst>
                <a:ext uri="{FF2B5EF4-FFF2-40B4-BE49-F238E27FC236}">
                  <a16:creationId xmlns:a16="http://schemas.microsoft.com/office/drawing/2014/main" id="{FB57A0A2-4725-4B83-E865-CAD512EA5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5" y="2176"/>
              <a:ext cx="4080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.: ***.***:*** :**:  .: :*:  : *  ***. :: . *: *:: *:.:*:..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1">
              <a:extLst>
                <a:ext uri="{FF2B5EF4-FFF2-40B4-BE49-F238E27FC236}">
                  <a16:creationId xmlns:a16="http://schemas.microsoft.com/office/drawing/2014/main" id="{FCFCD2C6-5FFD-28D2-3675-20097160CA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2176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2">
              <a:extLst>
                <a:ext uri="{FF2B5EF4-FFF2-40B4-BE49-F238E27FC236}">
                  <a16:creationId xmlns:a16="http://schemas.microsoft.com/office/drawing/2014/main" id="{F56938CA-6506-ACAB-B817-DF55978CF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171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103">
              <a:extLst>
                <a:ext uri="{FF2B5EF4-FFF2-40B4-BE49-F238E27FC236}">
                  <a16:creationId xmlns:a16="http://schemas.microsoft.com/office/drawing/2014/main" id="{498D28E7-C183-EDA4-5749-03264774E1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171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Rectangle 104">
              <a:extLst>
                <a:ext uri="{FF2B5EF4-FFF2-40B4-BE49-F238E27FC236}">
                  <a16:creationId xmlns:a16="http://schemas.microsoft.com/office/drawing/2014/main" id="{1F86AC93-2061-7451-29D5-C0F2BF8398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334"/>
              <a:ext cx="5077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Rectangle 105">
              <a:extLst>
                <a:ext uri="{FF2B5EF4-FFF2-40B4-BE49-F238E27FC236}">
                  <a16:creationId xmlns:a16="http://schemas.microsoft.com/office/drawing/2014/main" id="{AE5CBDF4-9186-D11E-6575-A1492A46E2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339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6">
              <a:extLst>
                <a:ext uri="{FF2B5EF4-FFF2-40B4-BE49-F238E27FC236}">
                  <a16:creationId xmlns:a16="http://schemas.microsoft.com/office/drawing/2014/main" id="{8665DEFC-EE46-233B-9C05-D473173EE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334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Rectangle 107">
              <a:extLst>
                <a:ext uri="{FF2B5EF4-FFF2-40B4-BE49-F238E27FC236}">
                  <a16:creationId xmlns:a16="http://schemas.microsoft.com/office/drawing/2014/main" id="{F5DE7FCD-06B2-89A1-9CBA-1AD3662B6B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334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Rectangle 108">
              <a:extLst>
                <a:ext uri="{FF2B5EF4-FFF2-40B4-BE49-F238E27FC236}">
                  <a16:creationId xmlns:a16="http://schemas.microsoft.com/office/drawing/2014/main" id="{EC1D7B2C-1F9E-0CA2-D435-29A82455BD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496"/>
              <a:ext cx="5077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109">
              <a:extLst>
                <a:ext uri="{FF2B5EF4-FFF2-40B4-BE49-F238E27FC236}">
                  <a16:creationId xmlns:a16="http://schemas.microsoft.com/office/drawing/2014/main" id="{34767BE2-8737-79DE-98EE-0AEC4772FB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501"/>
              <a:ext cx="339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ap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10">
              <a:extLst>
                <a:ext uri="{FF2B5EF4-FFF2-40B4-BE49-F238E27FC236}">
                  <a16:creationId xmlns:a16="http://schemas.microsoft.com/office/drawing/2014/main" id="{0A293E77-C907-EC51-EED9-876E3B093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7" y="2501"/>
              <a:ext cx="4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1">
              <a:extLst>
                <a:ext uri="{FF2B5EF4-FFF2-40B4-BE49-F238E27FC236}">
                  <a16:creationId xmlns:a16="http://schemas.microsoft.com/office/drawing/2014/main" id="{F72C6AEB-632A-2D04-B527-613CD46B6C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" y="2501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2">
              <a:extLst>
                <a:ext uri="{FF2B5EF4-FFF2-40B4-BE49-F238E27FC236}">
                  <a16:creationId xmlns:a16="http://schemas.microsoft.com/office/drawing/2014/main" id="{6D8D5384-AD46-C4E6-7205-84BF2A24BD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2501"/>
              <a:ext cx="414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EEGTTDVEYLVNKVLYMATMNYKTYLTVNSMNAKFFNRFSFTTKIFSRRIRQTLSDIIRW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3">
              <a:extLst>
                <a:ext uri="{FF2B5EF4-FFF2-40B4-BE49-F238E27FC236}">
                  <a16:creationId xmlns:a16="http://schemas.microsoft.com/office/drawing/2014/main" id="{F8004E69-448E-16F5-1757-C75490137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2501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14">
              <a:extLst>
                <a:ext uri="{FF2B5EF4-FFF2-40B4-BE49-F238E27FC236}">
                  <a16:creationId xmlns:a16="http://schemas.microsoft.com/office/drawing/2014/main" id="{DC939A10-CCD8-A8AD-F984-161FAAA9C6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496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115">
              <a:extLst>
                <a:ext uri="{FF2B5EF4-FFF2-40B4-BE49-F238E27FC236}">
                  <a16:creationId xmlns:a16="http://schemas.microsoft.com/office/drawing/2014/main" id="{072FDE19-3F3E-4EC0-3163-299D7604CB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496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Rectangle 116">
              <a:extLst>
                <a:ext uri="{FF2B5EF4-FFF2-40B4-BE49-F238E27FC236}">
                  <a16:creationId xmlns:a16="http://schemas.microsoft.com/office/drawing/2014/main" id="{CA087B1C-D815-C2BB-88DC-2906F0E423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658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117">
              <a:extLst>
                <a:ext uri="{FF2B5EF4-FFF2-40B4-BE49-F238E27FC236}">
                  <a16:creationId xmlns:a16="http://schemas.microsoft.com/office/drawing/2014/main" id="{C7E87125-381F-C813-BD98-E6FFE2189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664"/>
              <a:ext cx="81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RA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8">
              <a:extLst>
                <a:ext uri="{FF2B5EF4-FFF2-40B4-BE49-F238E27FC236}">
                  <a16:creationId xmlns:a16="http://schemas.microsoft.com/office/drawing/2014/main" id="{7D70F755-6CFF-2ADE-E51B-77308961D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2664"/>
              <a:ext cx="203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RK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19">
              <a:extLst>
                <a:ext uri="{FF2B5EF4-FFF2-40B4-BE49-F238E27FC236}">
                  <a16:creationId xmlns:a16="http://schemas.microsoft.com/office/drawing/2014/main" id="{62885A33-747F-5FBE-2865-9A745C2D86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0" y="2664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-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20">
              <a:extLst>
                <a:ext uri="{FF2B5EF4-FFF2-40B4-BE49-F238E27FC236}">
                  <a16:creationId xmlns:a16="http://schemas.microsoft.com/office/drawing/2014/main" id="{31E34FEC-EFE3-82F4-A8B0-82A335BEEB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" y="2664"/>
              <a:ext cx="3944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IDRRDLFLSRYLFMTTIYYKTYTTIEKMKTSLQNNMKIARYLCSKRIRKALGNILKV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1">
              <a:extLst>
                <a:ext uri="{FF2B5EF4-FFF2-40B4-BE49-F238E27FC236}">
                  <a16:creationId xmlns:a16="http://schemas.microsoft.com/office/drawing/2014/main" id="{330A0FEA-12C2-DE82-E92C-E8FFF8630A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2664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2">
              <a:extLst>
                <a:ext uri="{FF2B5EF4-FFF2-40B4-BE49-F238E27FC236}">
                  <a16:creationId xmlns:a16="http://schemas.microsoft.com/office/drawing/2014/main" id="{7E78BCF5-7F4B-4DCD-BA09-109F9F1E64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65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Rectangle 123">
              <a:extLst>
                <a:ext uri="{FF2B5EF4-FFF2-40B4-BE49-F238E27FC236}">
                  <a16:creationId xmlns:a16="http://schemas.microsoft.com/office/drawing/2014/main" id="{C8766EC4-974F-D72F-50EF-FF02C8B81E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658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Rectangle 124">
              <a:extLst>
                <a:ext uri="{FF2B5EF4-FFF2-40B4-BE49-F238E27FC236}">
                  <a16:creationId xmlns:a16="http://schemas.microsoft.com/office/drawing/2014/main" id="{8EF5D809-3877-AD3A-05D4-65B4D7E99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821"/>
              <a:ext cx="5077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Rectangle 125">
              <a:extLst>
                <a:ext uri="{FF2B5EF4-FFF2-40B4-BE49-F238E27FC236}">
                  <a16:creationId xmlns:a16="http://schemas.microsoft.com/office/drawing/2014/main" id="{D97C4609-BA9C-F7A4-596B-5D706D2FEC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827"/>
              <a:ext cx="81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126">
              <a:extLst>
                <a:ext uri="{FF2B5EF4-FFF2-40B4-BE49-F238E27FC236}">
                  <a16:creationId xmlns:a16="http://schemas.microsoft.com/office/drawing/2014/main" id="{0EA2AE00-85BB-FBCD-ED69-EC5BC3C01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" y="2827"/>
              <a:ext cx="4147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.:     : ::.: *:*:*: **** *::.*::.: *.:.::  : *:***::*.:*::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Rectangle 127">
              <a:extLst>
                <a:ext uri="{FF2B5EF4-FFF2-40B4-BE49-F238E27FC236}">
                  <a16:creationId xmlns:a16="http://schemas.microsoft.com/office/drawing/2014/main" id="{189F25A2-0FED-9B30-E335-A737F6E41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2827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" name="Rectangle 128">
              <a:extLst>
                <a:ext uri="{FF2B5EF4-FFF2-40B4-BE49-F238E27FC236}">
                  <a16:creationId xmlns:a16="http://schemas.microsoft.com/office/drawing/2014/main" id="{F542FD07-2F62-056F-A8C4-69610CE14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821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129">
              <a:extLst>
                <a:ext uri="{FF2B5EF4-FFF2-40B4-BE49-F238E27FC236}">
                  <a16:creationId xmlns:a16="http://schemas.microsoft.com/office/drawing/2014/main" id="{A710F458-5613-B9A5-D56C-44241F9060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821"/>
              <a:ext cx="3" cy="162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Rectangle 130">
              <a:extLst>
                <a:ext uri="{FF2B5EF4-FFF2-40B4-BE49-F238E27FC236}">
                  <a16:creationId xmlns:a16="http://schemas.microsoft.com/office/drawing/2014/main" id="{75C3B99D-E6AF-96E7-C455-25BE998AB3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2983"/>
              <a:ext cx="5077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131">
              <a:extLst>
                <a:ext uri="{FF2B5EF4-FFF2-40B4-BE49-F238E27FC236}">
                  <a16:creationId xmlns:a16="http://schemas.microsoft.com/office/drawing/2014/main" id="{A1CF2FE9-2A87-BECC-A9BA-C46920482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2989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32">
              <a:extLst>
                <a:ext uri="{FF2B5EF4-FFF2-40B4-BE49-F238E27FC236}">
                  <a16:creationId xmlns:a16="http://schemas.microsoft.com/office/drawing/2014/main" id="{CF35FCA1-F855-E0AB-D40A-CA185D88F0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298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133">
              <a:extLst>
                <a:ext uri="{FF2B5EF4-FFF2-40B4-BE49-F238E27FC236}">
                  <a16:creationId xmlns:a16="http://schemas.microsoft.com/office/drawing/2014/main" id="{B6A5DFD7-F956-4985-EFF7-A200F6758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2983"/>
              <a:ext cx="3" cy="163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Rectangle 134">
              <a:extLst>
                <a:ext uri="{FF2B5EF4-FFF2-40B4-BE49-F238E27FC236}">
                  <a16:creationId xmlns:a16="http://schemas.microsoft.com/office/drawing/2014/main" id="{F9E78402-AE96-2FDE-8091-23811C94FE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" y="3146"/>
              <a:ext cx="5077" cy="2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136">
              <a:extLst>
                <a:ext uri="{FF2B5EF4-FFF2-40B4-BE49-F238E27FC236}">
                  <a16:creationId xmlns:a16="http://schemas.microsoft.com/office/drawing/2014/main" id="{61679B81-3472-8FEE-79C7-B2B24D49B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7" y="3150"/>
              <a:ext cx="475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    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37">
              <a:extLst>
                <a:ext uri="{FF2B5EF4-FFF2-40B4-BE49-F238E27FC236}">
                  <a16:creationId xmlns:a16="http://schemas.microsoft.com/office/drawing/2014/main" id="{18782347-E4C7-F82F-BF71-FAF0315747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" y="3150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40">
              <a:extLst>
                <a:ext uri="{FF2B5EF4-FFF2-40B4-BE49-F238E27FC236}">
                  <a16:creationId xmlns:a16="http://schemas.microsoft.com/office/drawing/2014/main" id="{0DAEF32B-CFF0-4A2E-EA04-D34891EFB1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8" y="3150"/>
              <a:ext cx="0" cy="16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41">
              <a:extLst>
                <a:ext uri="{FF2B5EF4-FFF2-40B4-BE49-F238E27FC236}">
                  <a16:creationId xmlns:a16="http://schemas.microsoft.com/office/drawing/2014/main" id="{D94EC71C-305C-7F59-9CB2-68DF65539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2" y="3150"/>
              <a:ext cx="136" cy="1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Courier New" panose="02070309020205020404" pitchFamily="49" charset="0"/>
                </a:rPr>
                <a:t> 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42">
              <a:extLst>
                <a:ext uri="{FF2B5EF4-FFF2-40B4-BE49-F238E27FC236}">
                  <a16:creationId xmlns:a16="http://schemas.microsoft.com/office/drawing/2014/main" id="{6B96864A-9334-0352-3A2B-8B48421DDD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3397"/>
              <a:ext cx="5274" cy="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Rectangle 143">
              <a:extLst>
                <a:ext uri="{FF2B5EF4-FFF2-40B4-BE49-F238E27FC236}">
                  <a16:creationId xmlns:a16="http://schemas.microsoft.com/office/drawing/2014/main" id="{375B212A-1DA7-6C7A-E8C0-23AC76579F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3397"/>
              <a:ext cx="3" cy="8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Rectangle 144">
              <a:extLst>
                <a:ext uri="{FF2B5EF4-FFF2-40B4-BE49-F238E27FC236}">
                  <a16:creationId xmlns:a16="http://schemas.microsoft.com/office/drawing/2014/main" id="{E20F4670-5F77-B4DA-76C5-767CE877C2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6" y="3146"/>
              <a:ext cx="3" cy="2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7" name="Rectangle 145">
              <a:extLst>
                <a:ext uri="{FF2B5EF4-FFF2-40B4-BE49-F238E27FC236}">
                  <a16:creationId xmlns:a16="http://schemas.microsoft.com/office/drawing/2014/main" id="{08CB62A6-B56A-B75A-B339-0ADB37BCBA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" y="3146"/>
              <a:ext cx="3" cy="251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69083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A6E48AF-B753-72B0-0DDA-093BE7C97F7C}"/>
              </a:ext>
            </a:extLst>
          </p:cNvPr>
          <p:cNvSpPr txBox="1"/>
          <p:nvPr/>
        </p:nvSpPr>
        <p:spPr>
          <a:xfrm>
            <a:off x="264405" y="396604"/>
            <a:ext cx="11927595" cy="60819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kkavfttliglyathvmgirhtnslpgrsqdamlvdalasglse-syarinaiedetdi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59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k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reiglaiqklfeirifgcargd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fttsgrplvfyrnvkrinaeaet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51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*:.   .  ***   ::: **  ..  *           :**     * .:: *: *::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r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vesirhnpniqdavcarfikkqlcheivtvyv</a:t>
            </a:r>
            <a:r>
              <a:rPr lang="en-US" sz="14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c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qgqc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dte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09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ecigliipdeladlpryascglmrfkms-mfr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tt-y</a:t>
            </a:r>
            <a:r>
              <a:rPr lang="en-US" sz="14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c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gelqfarllgkvt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07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* .     : :.: . *.  ..   **  . : :   *.  </a:t>
            </a:r>
            <a:r>
              <a:rPr lang="en-US" sz="14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: * *  : ..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qhplndpnptirlpntyqleaafyifknllkqyskqrhmegkrfrsksksnlyrlfmsll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69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qdikrrrptielpktyqleeatytlkkeadndirqektp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lnifrkvrk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	158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: ::  </a:t>
            </a:r>
            <a:r>
              <a:rPr lang="en-US" sz="14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.***.**:***** * * :*:  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.:  :*.:            *::* . . 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knmffrkidrrdlflsrylfmttiyyktyttiekmktslqnnmkiary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csk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	223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ktfsnvdfanc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qchlilvtvyaqmldhcqgigkpdmtlmailefvevcladnnv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214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* ::*  :   . :*::.*:* :     : : .   . * * .:  :*     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rkalgnilkvnirg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vkdtpanyitaktrdyeiylrrqqsesgtft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	271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qarrllndaevvlqqmieaneeeslflsyltakirtlq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yhlesgllsearkkln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271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*: :    :*:  *..   :.   .*:*** *  :    * : *** ::      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---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fvnmsldilikmvtklqmqadkpwykkwyyvftkpvkwavnlienddapyg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24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mnslgyhfprhkfsinlkstiql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lrwkli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kpwkidtadeltmny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	321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.* . .:.* :* . :*          :*  :   *  * ::  ::    * 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wdkmkgnkkakeeefdefasninni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	349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---</a:t>
            </a:r>
            <a:r>
              <a:rPr lang="en-US" sz="14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eqlatclaqkfevfrvkivacnlllyfl</a:t>
            </a:r>
            <a:r>
              <a:rPr lang="en-US" sz="14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50</a:t>
            </a:r>
            <a:endParaRPr lang="en-US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626623-B503-7E6F-D274-F6CEA015D5A2}"/>
              </a:ext>
            </a:extLst>
          </p:cNvPr>
          <p:cNvSpPr txBox="1"/>
          <p:nvPr/>
        </p:nvSpPr>
        <p:spPr>
          <a:xfrm>
            <a:off x="8922716" y="646139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3A096E3-E90D-C5EC-7F12-48C79DA3B26B}"/>
              </a:ext>
            </a:extLst>
          </p:cNvPr>
          <p:cNvSpPr/>
          <p:nvPr/>
        </p:nvSpPr>
        <p:spPr>
          <a:xfrm>
            <a:off x="2154803" y="2235464"/>
            <a:ext cx="1606492" cy="707666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661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7C968C3C-5758-1913-93A6-ECF1F8C2FC1B}"/>
              </a:ext>
            </a:extLst>
          </p:cNvPr>
          <p:cNvSpPr txBox="1"/>
          <p:nvPr/>
        </p:nvSpPr>
        <p:spPr>
          <a:xfrm>
            <a:off x="3048802" y="175707"/>
            <a:ext cx="6097604" cy="65113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---------------------------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kkavftt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l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t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hvmgi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nslpg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28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                                m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dksvre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l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iq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fei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gcarg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01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                                m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dksare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l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q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fei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gcarg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900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::: 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..  *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sqdamlvda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sgl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rinaiedetdia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mv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irhnpniqdav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8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f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sg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v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rnvkrinaeaeta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liipdeladlpryas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53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f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sg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v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rnvkrisveaeia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liipdeladlpryas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95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: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.:: *. *:: 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:     :.: . *.  ..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kk----------------ql---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ivtv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000" kern="0" dirty="0" err="1">
                <a:solidFill>
                  <a:srgbClr val="0070C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</a:t>
            </a:r>
            <a:r>
              <a:rPr lang="en-US" sz="1000" kern="0" dirty="0" err="1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qgq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dteqhplndpn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18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smfrett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</a:t>
            </a:r>
            <a:r>
              <a:rPr lang="en-US" sz="1000" kern="0" dirty="0" err="1">
                <a:solidFill>
                  <a:srgbClr val="0070C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</a:t>
            </a:r>
            <a:r>
              <a:rPr lang="en-US" sz="1000" kern="0" dirty="0" err="1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lqfarllgkvtaqdikrrr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90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smfrett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sltenhkielhnkalkflqrht</a:t>
            </a:r>
            <a:r>
              <a:rPr lang="en-US" sz="1000" kern="0" dirty="0" err="1">
                <a:solidFill>
                  <a:srgbClr val="0070C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</a:t>
            </a:r>
            <a:r>
              <a:rPr lang="en-US" sz="1000" kern="0" dirty="0" err="1">
                <a:solidFill>
                  <a:srgbClr val="FF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</a:t>
            </a:r>
            <a:r>
              <a:rPr lang="en-US" sz="1000" kern="0" dirty="0" err="1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lqfakllgkvtaqdikrrr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01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.                       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: * *  : ..  : ::  .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qle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llkqyskqrhmegkrfrsksks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ly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fmsl-lmr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nmf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77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qle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t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adndirqektp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f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vrkpikt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vd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443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p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qle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p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eadde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ka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f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rkplktf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snvdf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06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.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:*:  .:    .:     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::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. .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.*: *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drrdlflsry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fmttiyy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ttiekmktslqnnmkiary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csk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kal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	229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qch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lvtvyaq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dhcqgigkpdmtlmailefvevcladnnvpqarrlln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496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qch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litvysq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mldhcqgigkpdmilmailefvevclaennipqarrlln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115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: : :      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:: *:* :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: : .     * * .:  :*    .:   *: *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nilkvnirg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vkdtpan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ita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yeiylrrqqs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gtft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	27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evvlqqmieaneeeslfls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lta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lq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yh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glls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rkklneamnslgy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553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evvlqqmfeaheeesifls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yltak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lq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ch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glls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kkklneamnslgy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17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:*:  :..   :.   .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:*** 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:    * :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vnmsldilikmvtklqm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qadkpwyk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wyyv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ftkpvkwavnlienddapygwdkmkgnk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332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hfprhkfsinlks</a:t>
            </a:r>
            <a:r>
              <a:rPr lang="en-US" sz="1000" kern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ql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wkl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kpwkidtadeltmny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ql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600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hfprhkfsinlks</a:t>
            </a:r>
            <a:r>
              <a:rPr lang="en-US" sz="1000" kern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mql</a:t>
            </a:r>
            <a:r>
              <a:rPr lang="en-US" sz="1000" kern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l</a:t>
            </a:r>
            <a:r>
              <a:rPr lang="en-US" sz="1000" kern="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wkl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kpwkidvadeltmny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eqla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219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.* . .:.* :*   .:*:        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:*  :   *  * ::  ::    *     :  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RRA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keeefdefasnin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----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----	349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1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laqkfevfrvkivacnll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fl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---------	624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2    </a:t>
            </a:r>
            <a:r>
              <a:rPr lang="en-US" sz="1000" kern="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lalmfevfrgtmdmktharlaalwslnaalnssrdfitlctsltnmmltahvyqkrsv</a:t>
            </a: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	1279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.    *: *  .:                                              </a:t>
            </a:r>
            <a:endParaRPr lang="en-US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186638-BB4D-2E69-ECCD-F25C27B60750}"/>
              </a:ext>
            </a:extLst>
          </p:cNvPr>
          <p:cNvSpPr txBox="1"/>
          <p:nvPr/>
        </p:nvSpPr>
        <p:spPr>
          <a:xfrm>
            <a:off x="9441500" y="6466849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 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458C379-AF6D-60F7-1A09-BD129D3E0C1D}"/>
              </a:ext>
            </a:extLst>
          </p:cNvPr>
          <p:cNvCxnSpPr>
            <a:cxnSpLocks/>
          </p:cNvCxnSpPr>
          <p:nvPr/>
        </p:nvCxnSpPr>
        <p:spPr>
          <a:xfrm>
            <a:off x="8163612" y="1866507"/>
            <a:ext cx="0" cy="509048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F7A3AC4E-0DCD-8EBE-96A5-21E66542AACE}"/>
              </a:ext>
            </a:extLst>
          </p:cNvPr>
          <p:cNvCxnSpPr/>
          <p:nvPr/>
        </p:nvCxnSpPr>
        <p:spPr>
          <a:xfrm>
            <a:off x="8163612" y="1866507"/>
            <a:ext cx="754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F21F4A5-FE29-D29A-BFC9-CB136E341BB1}"/>
              </a:ext>
            </a:extLst>
          </p:cNvPr>
          <p:cNvCxnSpPr/>
          <p:nvPr/>
        </p:nvCxnSpPr>
        <p:spPr>
          <a:xfrm>
            <a:off x="8163612" y="2375555"/>
            <a:ext cx="754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0A9ADE1-8E14-67BB-C5B8-B44560F68608}"/>
              </a:ext>
            </a:extLst>
          </p:cNvPr>
          <p:cNvCxnSpPr/>
          <p:nvPr/>
        </p:nvCxnSpPr>
        <p:spPr>
          <a:xfrm>
            <a:off x="3695307" y="2648932"/>
            <a:ext cx="104637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8BB4CBC-D385-3701-FC3E-5C9288F75372}"/>
              </a:ext>
            </a:extLst>
          </p:cNvPr>
          <p:cNvCxnSpPr/>
          <p:nvPr/>
        </p:nvCxnSpPr>
        <p:spPr>
          <a:xfrm>
            <a:off x="3695307" y="3167407"/>
            <a:ext cx="104637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79380BD-830B-2312-8F16-BAE22418EB80}"/>
              </a:ext>
            </a:extLst>
          </p:cNvPr>
          <p:cNvCxnSpPr/>
          <p:nvPr/>
        </p:nvCxnSpPr>
        <p:spPr>
          <a:xfrm>
            <a:off x="4741682" y="2648932"/>
            <a:ext cx="0" cy="518475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895659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54D7EA6-76D9-122B-CE84-66059649B5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1" t="17990" r="2691" b="2467"/>
          <a:stretch/>
        </p:blipFill>
        <p:spPr>
          <a:xfrm>
            <a:off x="2899404" y="555171"/>
            <a:ext cx="4941326" cy="237960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9BD72B2-4728-3BC1-ECAE-98D560D4E1FE}"/>
              </a:ext>
            </a:extLst>
          </p:cNvPr>
          <p:cNvSpPr txBox="1"/>
          <p:nvPr/>
        </p:nvSpPr>
        <p:spPr>
          <a:xfrm>
            <a:off x="9364337" y="6436318"/>
            <a:ext cx="2711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5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2FB707-1830-51FF-F84D-32E0168C39FC}"/>
              </a:ext>
            </a:extLst>
          </p:cNvPr>
          <p:cNvSpPr txBox="1"/>
          <p:nvPr/>
        </p:nvSpPr>
        <p:spPr>
          <a:xfrm>
            <a:off x="2418985" y="7867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2A537E-C3A8-C42D-CAEB-BEE254FF9CB6}"/>
              </a:ext>
            </a:extLst>
          </p:cNvPr>
          <p:cNvSpPr txBox="1"/>
          <p:nvPr/>
        </p:nvSpPr>
        <p:spPr>
          <a:xfrm>
            <a:off x="2418985" y="301970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B4F5B9D-CD44-BE63-F04B-DEB43AF3F1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341" t="9684"/>
          <a:stretch/>
        </p:blipFill>
        <p:spPr>
          <a:xfrm>
            <a:off x="2899404" y="3663530"/>
            <a:ext cx="2343639" cy="355146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D022CBB-9663-51A6-F9E0-192984F22224}"/>
              </a:ext>
            </a:extLst>
          </p:cNvPr>
          <p:cNvSpPr txBox="1"/>
          <p:nvPr/>
        </p:nvSpPr>
        <p:spPr>
          <a:xfrm>
            <a:off x="2899404" y="3294198"/>
            <a:ext cx="2041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15mer RRA a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4BA384-52BE-F176-36FD-C1A141068510}"/>
              </a:ext>
            </a:extLst>
          </p:cNvPr>
          <p:cNvSpPr txBox="1"/>
          <p:nvPr/>
        </p:nvSpPr>
        <p:spPr>
          <a:xfrm>
            <a:off x="5831692" y="3285937"/>
            <a:ext cx="1308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ti-HIS a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936B22EF-3F29-9AC8-524F-F61DFF9B89DF}"/>
              </a:ext>
            </a:extLst>
          </p:cNvPr>
          <p:cNvGrpSpPr/>
          <p:nvPr/>
        </p:nvGrpSpPr>
        <p:grpSpPr>
          <a:xfrm>
            <a:off x="5243043" y="3826818"/>
            <a:ext cx="2370640" cy="3145809"/>
            <a:chOff x="5194623" y="1856095"/>
            <a:chExt cx="2370640" cy="314580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CC5345B9-241B-DA7C-0BE1-8021D12F85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59936"/>
            <a:stretch/>
          </p:blipFill>
          <p:spPr>
            <a:xfrm>
              <a:off x="5194623" y="1856095"/>
              <a:ext cx="1177298" cy="3145809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5990F5B-508C-1CCA-CE96-B6143F117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7425"/>
            <a:stretch/>
          </p:blipFill>
          <p:spPr>
            <a:xfrm>
              <a:off x="6314173" y="1856095"/>
              <a:ext cx="1251090" cy="314580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529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29</TotalTime>
  <Words>662</Words>
  <Application>Microsoft Office PowerPoint</Application>
  <PresentationFormat>Widescreen</PresentationFormat>
  <Paragraphs>17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arez, Carlos Esteban</dc:creator>
  <cp:lastModifiedBy>Suarez, Carlos Esteban</cp:lastModifiedBy>
  <cp:revision>10</cp:revision>
  <dcterms:created xsi:type="dcterms:W3CDTF">2024-02-01T17:51:12Z</dcterms:created>
  <dcterms:modified xsi:type="dcterms:W3CDTF">2024-03-25T17:38:10Z</dcterms:modified>
</cp:coreProperties>
</file>